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8742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698FA8-34FF-4BEF-82AC-C8E7D889087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581508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080" y="6446160"/>
            <a:ext cx="581508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5675DF-7D76-4782-9EB7-2202223C6D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08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49380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3C8693-F868-4FC2-AB7C-0459847BF8C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0400" y="264168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46720" y="264168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080" y="644616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0400" y="644616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46720" y="644616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10AC05-FD3B-41F6-A16F-C9A6A644DC1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080" y="2641680"/>
            <a:ext cx="5815080" cy="728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80A233-F27C-4CD9-9291-7DAE37B0D0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581508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51C7F9-A648-44C0-8DA0-22A597BF1CD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097CC8-8045-4328-8051-652F6C7AB7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99C198-72F1-4FA4-BEE8-703606AC04E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080" y="812520"/>
            <a:ext cx="5815080" cy="6998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69AD3F-BDF7-4137-8A8C-FAEE5FA246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08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130F9C-5045-42EA-BD0D-E3011ECA5D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49380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97A2EA-AE4B-4BB5-8603-38AF0F01B1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080" y="6446160"/>
            <a:ext cx="581508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DCE5BA-B14A-4A88-921C-B51ECD213D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080" y="2641680"/>
            <a:ext cx="581508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14440" cy="59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2880" y="8331120"/>
            <a:ext cx="2157480" cy="59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31120"/>
            <a:ext cx="1414440" cy="59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nl-NL" sz="2400" spc="-1" strike="noStrike">
                <a:solidFill>
                  <a:srgbClr val="000000"/>
                </a:solidFill>
                <a:latin typeface="Times New Roman"/>
                <a:ea typeface="Lucida Sans Unicode"/>
              </a:defRPr>
            </a:lvl1pPr>
          </a:lstStyle>
          <a:p>
            <a:pPr indent="0"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26C1BFB5-8344-4349-AE72-1793C8B534F9}" type="slidenum">
              <a:rPr b="0" lang="nl-NL" sz="2400" spc="-1" strike="noStrike">
                <a:solidFill>
                  <a:srgbClr val="000000"/>
                </a:solidFill>
                <a:latin typeface="Times New Roman"/>
                <a:ea typeface="Lucida Sans Unicode"/>
              </a:rPr>
              <a:t>&lt;number&gt;</a:t>
            </a:fld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Grafiek 1" descr=""/>
          <p:cNvPicPr/>
          <p:nvPr/>
        </p:nvPicPr>
        <p:blipFill>
          <a:blip r:embed="rId1"/>
          <a:stretch/>
        </p:blipFill>
        <p:spPr>
          <a:xfrm>
            <a:off x="115920" y="103320"/>
            <a:ext cx="1974960" cy="2828880"/>
          </a:xfrm>
          <a:prstGeom prst="rect">
            <a:avLst/>
          </a:prstGeom>
          <a:ln w="0">
            <a:noFill/>
          </a:ln>
        </p:spPr>
      </p:pic>
      <p:sp>
        <p:nvSpPr>
          <p:cNvPr id="42" name="Text Box 4"/>
          <p:cNvSpPr/>
          <p:nvPr/>
        </p:nvSpPr>
        <p:spPr>
          <a:xfrm>
            <a:off x="0" y="8710560"/>
            <a:ext cx="685800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nl-NL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S4 Fig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Expression levels of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TSHb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 in the pituitary of 16-week-old WT and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Ercc1</a:t>
            </a:r>
            <a:r>
              <a:rPr b="0" i="1" lang="en-US" sz="1100" spc="-1" strike="noStrike" baseline="30000">
                <a:solidFill>
                  <a:srgbClr val="000000"/>
                </a:solidFill>
                <a:latin typeface="Arial"/>
                <a:ea typeface="Lucida Sans Unicode"/>
              </a:rPr>
              <a:t>-/Δ-7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 mice. . Values represent mean ± SE </a:t>
            </a:r>
            <a:endParaRPr b="0" lang="en-US" sz="11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5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09T09:26:31Z</dcterms:created>
  <dc:creator>USER</dc:creator>
  <dc:description/>
  <dc:language>en-US</dc:language>
  <cp:lastModifiedBy>Edward Visser</cp:lastModifiedBy>
  <dcterms:modified xsi:type="dcterms:W3CDTF">2016-02-11T12:45:15Z</dcterms:modified>
  <cp:revision>111</cp:revision>
  <dc:subject/>
  <dc:title>PowerPoint Presentation</dc:title>
</cp:coreProperties>
</file>